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72" r:id="rId3"/>
  </p:sldIdLst>
  <p:sldSz cx="6858000" cy="9906000" type="A4"/>
  <p:notesSz cx="6858000" cy="9144000"/>
  <p:custDataLst>
    <p:tags r:id="rId7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04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1608" y="6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 hasCustomPrompt="1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uppieren 23"/>
          <p:cNvGrpSpPr/>
          <p:nvPr/>
        </p:nvGrpSpPr>
        <p:grpSpPr>
          <a:xfrm>
            <a:off x="589975" y="706325"/>
            <a:ext cx="2956045" cy="299720"/>
            <a:chOff x="1091625" y="6063357"/>
            <a:chExt cx="2956045" cy="299720"/>
          </a:xfrm>
        </p:grpSpPr>
        <p:sp>
          <p:nvSpPr>
            <p:cNvPr id="14" name="文本框 13"/>
            <p:cNvSpPr txBox="1"/>
            <p:nvPr/>
          </p:nvSpPr>
          <p:spPr>
            <a:xfrm>
              <a:off x="3829865" y="6063357"/>
              <a:ext cx="217805" cy="29972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altLang="zh-C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1091625" y="6063357"/>
              <a:ext cx="217805" cy="29972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altLang="zh-C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0" name="图片 29" descr="GSE49155"/>
          <p:cNvPicPr>
            <a:picLocks noChangeAspect="1"/>
          </p:cNvPicPr>
          <p:nvPr/>
        </p:nvPicPr>
        <p:blipFill>
          <a:blip r:embed="rId1"/>
          <a:srcRect l="26898" t="25304" r="32426" b="40952"/>
          <a:stretch>
            <a:fillRect/>
          </a:stretch>
        </p:blipFill>
        <p:spPr>
          <a:xfrm>
            <a:off x="497205" y="946150"/>
            <a:ext cx="2462530" cy="1430020"/>
          </a:xfrm>
          <a:prstGeom prst="rect">
            <a:avLst/>
          </a:prstGeom>
        </p:spPr>
      </p:pic>
      <p:pic>
        <p:nvPicPr>
          <p:cNvPr id="7" name="图片 6" descr="human_lung_GSE4915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2355" y="975995"/>
            <a:ext cx="2264410" cy="1882775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0" y="3093720"/>
            <a:ext cx="6857999" cy="11684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. Workflow and analysis of the lung cohort (</a:t>
            </a:r>
            <a:r>
              <a:rPr lang="en-US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GSE49155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chematic illustration of the samples with available transcriptome data for males.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reated in BioRender. Han, R. (2024) BioRender.com/a46d858 (B) Dot plot shows Y chromosome-related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GSVA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scores for normal, premalignant and tumor samples for individual patients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ZGQ2OGFkOTMxOTRjMjAwNGJjNzU4YzIzNGY2NWUwNzUifQ=="/>
</p:tagLst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31</Words>
  <Application>WPS 演示</Application>
  <PresentationFormat>A4-Papier (210 x 297 mm)</PresentationFormat>
  <Paragraphs>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</vt:lpstr>
      <vt:lpstr>宋体</vt:lpstr>
      <vt:lpstr>Wingdings</vt:lpstr>
      <vt:lpstr>微软雅黑</vt:lpstr>
      <vt:lpstr>Calibri</vt:lpstr>
      <vt:lpstr>Arial Unicode MS</vt:lpstr>
      <vt:lpstr>Offic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eß, Jochen</dc:creator>
  <cp:lastModifiedBy>韩蕊</cp:lastModifiedBy>
  <cp:revision>37</cp:revision>
  <dcterms:created xsi:type="dcterms:W3CDTF">2024-09-10T14:28:00Z</dcterms:created>
  <dcterms:modified xsi:type="dcterms:W3CDTF">2025-07-21T02:03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6E60A1633A442EAA0CE53EB4377AEE4_13</vt:lpwstr>
  </property>
  <property fmtid="{D5CDD505-2E9C-101B-9397-08002B2CF9AE}" pid="3" name="KSOProductBuildVer">
    <vt:lpwstr>2052-12.1.0.21915</vt:lpwstr>
  </property>
</Properties>
</file>